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7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D60A045-96A9-4114-97AA-D15A132932BD}" v="13" dt="2022-01-31T20:42:28.29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69" d="100"/>
          <a:sy n="69" d="100"/>
        </p:scale>
        <p:origin x="556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microsoft.com/office/2015/10/relationships/revisionInfo" Target="revisionInfo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Passero, Lauren Elizabeth" userId="378cea5f-8513-4130-9c0d-5ff0765b6f5e" providerId="ADAL" clId="{2D60A045-96A9-4114-97AA-D15A132932BD}"/>
    <pc:docChg chg="custSel delSld modSld">
      <pc:chgData name="Passero, Lauren Elizabeth" userId="378cea5f-8513-4130-9c0d-5ff0765b6f5e" providerId="ADAL" clId="{2D60A045-96A9-4114-97AA-D15A132932BD}" dt="2022-01-31T20:43:03.168" v="980" actId="1076"/>
      <pc:docMkLst>
        <pc:docMk/>
      </pc:docMkLst>
      <pc:sldChg chg="del">
        <pc:chgData name="Passero, Lauren Elizabeth" userId="378cea5f-8513-4130-9c0d-5ff0765b6f5e" providerId="ADAL" clId="{2D60A045-96A9-4114-97AA-D15A132932BD}" dt="2022-01-31T20:30:53.893" v="822" actId="2696"/>
        <pc:sldMkLst>
          <pc:docMk/>
          <pc:sldMk cId="2652538318" sldId="256"/>
        </pc:sldMkLst>
      </pc:sldChg>
      <pc:sldChg chg="addSp modSp mod">
        <pc:chgData name="Passero, Lauren Elizabeth" userId="378cea5f-8513-4130-9c0d-5ff0765b6f5e" providerId="ADAL" clId="{2D60A045-96A9-4114-97AA-D15A132932BD}" dt="2022-01-31T20:43:03.168" v="980" actId="1076"/>
        <pc:sldMkLst>
          <pc:docMk/>
          <pc:sldMk cId="1297088771" sldId="257"/>
        </pc:sldMkLst>
        <pc:spChg chg="mod">
          <ac:chgData name="Passero, Lauren Elizabeth" userId="378cea5f-8513-4130-9c0d-5ff0765b6f5e" providerId="ADAL" clId="{2D60A045-96A9-4114-97AA-D15A132932BD}" dt="2022-01-31T20:13:23.839" v="288" actId="14100"/>
          <ac:spMkLst>
            <pc:docMk/>
            <pc:sldMk cId="1297088771" sldId="257"/>
            <ac:spMk id="6" creationId="{261DA521-9B82-47C1-AA17-C4E642444B0C}"/>
          </ac:spMkLst>
        </pc:spChg>
        <pc:spChg chg="mod">
          <ac:chgData name="Passero, Lauren Elizabeth" userId="378cea5f-8513-4130-9c0d-5ff0765b6f5e" providerId="ADAL" clId="{2D60A045-96A9-4114-97AA-D15A132932BD}" dt="2022-01-31T20:27:32.576" v="787" actId="1076"/>
          <ac:spMkLst>
            <pc:docMk/>
            <pc:sldMk cId="1297088771" sldId="257"/>
            <ac:spMk id="7" creationId="{64211532-FF01-44C3-A5FF-4A78645C8BF6}"/>
          </ac:spMkLst>
        </pc:spChg>
        <pc:spChg chg="mod">
          <ac:chgData name="Passero, Lauren Elizabeth" userId="378cea5f-8513-4130-9c0d-5ff0765b6f5e" providerId="ADAL" clId="{2D60A045-96A9-4114-97AA-D15A132932BD}" dt="2022-01-31T20:41:12.125" v="920" actId="1076"/>
          <ac:spMkLst>
            <pc:docMk/>
            <pc:sldMk cId="1297088771" sldId="257"/>
            <ac:spMk id="8" creationId="{C9F083B9-3FCB-4996-AE7A-DCE0B2D7C8F9}"/>
          </ac:spMkLst>
        </pc:spChg>
        <pc:spChg chg="mod">
          <ac:chgData name="Passero, Lauren Elizabeth" userId="378cea5f-8513-4130-9c0d-5ff0765b6f5e" providerId="ADAL" clId="{2D60A045-96A9-4114-97AA-D15A132932BD}" dt="2022-01-31T20:24:42.563" v="773" actId="1076"/>
          <ac:spMkLst>
            <pc:docMk/>
            <pc:sldMk cId="1297088771" sldId="257"/>
            <ac:spMk id="9" creationId="{3160ADF0-B111-4F8F-A060-2F3C804FD4E5}"/>
          </ac:spMkLst>
        </pc:spChg>
        <pc:spChg chg="mod">
          <ac:chgData name="Passero, Lauren Elizabeth" userId="378cea5f-8513-4130-9c0d-5ff0765b6f5e" providerId="ADAL" clId="{2D60A045-96A9-4114-97AA-D15A132932BD}" dt="2022-01-31T20:24:36.962" v="771" actId="1076"/>
          <ac:spMkLst>
            <pc:docMk/>
            <pc:sldMk cId="1297088771" sldId="257"/>
            <ac:spMk id="10" creationId="{A3BC80F5-311D-4BAA-8515-F29273D11556}"/>
          </ac:spMkLst>
        </pc:spChg>
        <pc:spChg chg="mod">
          <ac:chgData name="Passero, Lauren Elizabeth" userId="378cea5f-8513-4130-9c0d-5ff0765b6f5e" providerId="ADAL" clId="{2D60A045-96A9-4114-97AA-D15A132932BD}" dt="2022-01-31T20:27:34.696" v="788" actId="1076"/>
          <ac:spMkLst>
            <pc:docMk/>
            <pc:sldMk cId="1297088771" sldId="257"/>
            <ac:spMk id="11" creationId="{19863E36-61A1-4882-803C-F3E2DEF8DAF5}"/>
          </ac:spMkLst>
        </pc:spChg>
        <pc:spChg chg="mod">
          <ac:chgData name="Passero, Lauren Elizabeth" userId="378cea5f-8513-4130-9c0d-5ff0765b6f5e" providerId="ADAL" clId="{2D60A045-96A9-4114-97AA-D15A132932BD}" dt="2022-01-31T20:27:38.111" v="789" actId="1076"/>
          <ac:spMkLst>
            <pc:docMk/>
            <pc:sldMk cId="1297088771" sldId="257"/>
            <ac:spMk id="12" creationId="{535E7299-18B9-4800-9310-1A24B75FF02B}"/>
          </ac:spMkLst>
        </pc:spChg>
        <pc:spChg chg="add mod">
          <ac:chgData name="Passero, Lauren Elizabeth" userId="378cea5f-8513-4130-9c0d-5ff0765b6f5e" providerId="ADAL" clId="{2D60A045-96A9-4114-97AA-D15A132932BD}" dt="2022-01-31T20:41:18.541" v="921" actId="1076"/>
          <ac:spMkLst>
            <pc:docMk/>
            <pc:sldMk cId="1297088771" sldId="257"/>
            <ac:spMk id="14" creationId="{B87258BA-347D-4E4B-8E88-05122BCA2D79}"/>
          </ac:spMkLst>
        </pc:spChg>
        <pc:spChg chg="add mod">
          <ac:chgData name="Passero, Lauren Elizabeth" userId="378cea5f-8513-4130-9c0d-5ff0765b6f5e" providerId="ADAL" clId="{2D60A045-96A9-4114-97AA-D15A132932BD}" dt="2022-01-31T20:43:03.168" v="980" actId="1076"/>
          <ac:spMkLst>
            <pc:docMk/>
            <pc:sldMk cId="1297088771" sldId="257"/>
            <ac:spMk id="15" creationId="{95AAC233-737C-4014-9BC6-E46808B8B3D3}"/>
          </ac:spMkLst>
        </pc:spChg>
        <pc:cxnChg chg="add mod">
          <ac:chgData name="Passero, Lauren Elizabeth" userId="378cea5f-8513-4130-9c0d-5ff0765b6f5e" providerId="ADAL" clId="{2D60A045-96A9-4114-97AA-D15A132932BD}" dt="2022-01-31T20:13:23.839" v="288" actId="14100"/>
          <ac:cxnSpMkLst>
            <pc:docMk/>
            <pc:sldMk cId="1297088771" sldId="257"/>
            <ac:cxnSpMk id="17" creationId="{A3EE4327-3E78-452B-A5BA-A468112F0B5E}"/>
          </ac:cxnSpMkLst>
        </pc:cxnChg>
        <pc:cxnChg chg="add mod">
          <ac:chgData name="Passero, Lauren Elizabeth" userId="378cea5f-8513-4130-9c0d-5ff0765b6f5e" providerId="ADAL" clId="{2D60A045-96A9-4114-97AA-D15A132932BD}" dt="2022-01-25T19:27:05.797" v="163" actId="14100"/>
          <ac:cxnSpMkLst>
            <pc:docMk/>
            <pc:sldMk cId="1297088771" sldId="257"/>
            <ac:cxnSpMk id="18" creationId="{A6BAAD03-0062-46AC-ACD2-C637D8D9D886}"/>
          </ac:cxnSpMkLst>
        </pc:cxnChg>
        <pc:cxnChg chg="add mod">
          <ac:chgData name="Passero, Lauren Elizabeth" userId="378cea5f-8513-4130-9c0d-5ff0765b6f5e" providerId="ADAL" clId="{2D60A045-96A9-4114-97AA-D15A132932BD}" dt="2022-01-25T19:27:17.662" v="166" actId="14100"/>
          <ac:cxnSpMkLst>
            <pc:docMk/>
            <pc:sldMk cId="1297088771" sldId="257"/>
            <ac:cxnSpMk id="20" creationId="{655AE75B-F23C-4DAF-86CC-DFF4A4A686E6}"/>
          </ac:cxnSpMkLst>
        </pc:cxnChg>
        <pc:cxnChg chg="add mod">
          <ac:chgData name="Passero, Lauren Elizabeth" userId="378cea5f-8513-4130-9c0d-5ff0765b6f5e" providerId="ADAL" clId="{2D60A045-96A9-4114-97AA-D15A132932BD}" dt="2022-01-31T20:25:14.167" v="784" actId="1076"/>
          <ac:cxnSpMkLst>
            <pc:docMk/>
            <pc:sldMk cId="1297088771" sldId="257"/>
            <ac:cxnSpMk id="22" creationId="{8DE7C3B5-798B-45FA-BF83-1E9F15A6B008}"/>
          </ac:cxnSpMkLst>
        </pc:cxnChg>
        <pc:cxnChg chg="add mod">
          <ac:chgData name="Passero, Lauren Elizabeth" userId="378cea5f-8513-4130-9c0d-5ff0765b6f5e" providerId="ADAL" clId="{2D60A045-96A9-4114-97AA-D15A132932BD}" dt="2022-01-31T20:25:15.735" v="785" actId="1076"/>
          <ac:cxnSpMkLst>
            <pc:docMk/>
            <pc:sldMk cId="1297088771" sldId="257"/>
            <ac:cxnSpMk id="23" creationId="{D2AA4CB5-2904-4813-9933-04E11E1F5794}"/>
          </ac:cxnSpMkLst>
        </pc:cxnChg>
        <pc:cxnChg chg="add mod">
          <ac:chgData name="Passero, Lauren Elizabeth" userId="378cea5f-8513-4130-9c0d-5ff0765b6f5e" providerId="ADAL" clId="{2D60A045-96A9-4114-97AA-D15A132932BD}" dt="2022-01-31T20:25:17.806" v="786" actId="1076"/>
          <ac:cxnSpMkLst>
            <pc:docMk/>
            <pc:sldMk cId="1297088771" sldId="257"/>
            <ac:cxnSpMk id="24" creationId="{811192DD-7A99-4CDE-B236-FF15D56B73AC}"/>
          </ac:cxnSpMkLst>
        </pc:cxnChg>
        <pc:cxnChg chg="add mod">
          <ac:chgData name="Passero, Lauren Elizabeth" userId="378cea5f-8513-4130-9c0d-5ff0765b6f5e" providerId="ADAL" clId="{2D60A045-96A9-4114-97AA-D15A132932BD}" dt="2022-01-31T20:27:41.064" v="790" actId="1076"/>
          <ac:cxnSpMkLst>
            <pc:docMk/>
            <pc:sldMk cId="1297088771" sldId="257"/>
            <ac:cxnSpMk id="25" creationId="{ACA39EAE-F610-435E-AA17-662DD52EB3D8}"/>
          </ac:cxnSpMkLst>
        </pc:cxnChg>
        <pc:cxnChg chg="add mod">
          <ac:chgData name="Passero, Lauren Elizabeth" userId="378cea5f-8513-4130-9c0d-5ff0765b6f5e" providerId="ADAL" clId="{2D60A045-96A9-4114-97AA-D15A132932BD}" dt="2022-01-31T20:24:38.785" v="772" actId="1076"/>
          <ac:cxnSpMkLst>
            <pc:docMk/>
            <pc:sldMk cId="1297088771" sldId="257"/>
            <ac:cxnSpMk id="27" creationId="{9535232E-4F21-4D3E-895B-D00FB0E844E8}"/>
          </ac:cxnSpMkLst>
        </pc:cxnChg>
        <pc:cxnChg chg="add mod">
          <ac:chgData name="Passero, Lauren Elizabeth" userId="378cea5f-8513-4130-9c0d-5ff0765b6f5e" providerId="ADAL" clId="{2D60A045-96A9-4114-97AA-D15A132932BD}" dt="2022-01-31T20:27:45.746" v="791" actId="1076"/>
          <ac:cxnSpMkLst>
            <pc:docMk/>
            <pc:sldMk cId="1297088771" sldId="257"/>
            <ac:cxnSpMk id="28" creationId="{F43B86CB-80D7-4600-A832-495092BE4A9F}"/>
          </ac:cxnSpMkLst>
        </pc:cxnChg>
        <pc:cxnChg chg="add mod">
          <ac:chgData name="Passero, Lauren Elizabeth" userId="378cea5f-8513-4130-9c0d-5ff0765b6f5e" providerId="ADAL" clId="{2D60A045-96A9-4114-97AA-D15A132932BD}" dt="2022-01-31T20:41:26.445" v="922" actId="14100"/>
          <ac:cxnSpMkLst>
            <pc:docMk/>
            <pc:sldMk cId="1297088771" sldId="257"/>
            <ac:cxnSpMk id="31" creationId="{0F591363-4CB7-4434-8E9C-2AB7BB5E02BD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BE70E7-25C5-4518-9C75-1AF5E360D71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4521781-AD71-495C-B40E-2428E4B280F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51AE55-54A6-43B5-8105-3F5BC713C4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ACE2B-A0CA-4750-A3E8-D2DA0A07AD76}" type="datetimeFigureOut">
              <a:rPr lang="en-US" smtClean="0"/>
              <a:t>2/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210972-7CF7-445C-B075-B2D82A5BC7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64899D-9308-4137-803D-4C410AA3BB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35F9F9-7373-40DC-800D-DD74AD1248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64183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2D2101-E00E-4782-A71B-DCAF0AE884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A98C408-01D9-4E14-99EC-0CBE486D57A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B80341-3F0B-4EA0-AC56-56654F8A59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ACE2B-A0CA-4750-A3E8-D2DA0A07AD76}" type="datetimeFigureOut">
              <a:rPr lang="en-US" smtClean="0"/>
              <a:t>2/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C754D6-A2B4-48E6-BF40-2054F2C0DB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A27FBB-919E-45AA-A7C1-AEFA63B2E7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35F9F9-7373-40DC-800D-DD74AD1248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80236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8E2468A-1ADE-4783-887E-8CFFE2B4C63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4958D6B-80B2-43AB-A631-4456D480CAF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BB5A31-0B4D-4EF6-A26E-A9C6FAB406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ACE2B-A0CA-4750-A3E8-D2DA0A07AD76}" type="datetimeFigureOut">
              <a:rPr lang="en-US" smtClean="0"/>
              <a:t>2/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918EC0-C25D-4241-A591-CEBF823B28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154F88-808B-4AA1-8740-5DD696D8B9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35F9F9-7373-40DC-800D-DD74AD1248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79313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8B74C3-5961-4787-BF4D-3CD0C4CB7D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1821431-D67E-49E0-BAE8-A514F81C21E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42FB1C-F4E9-47A1-84A9-0DAE663BFC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ACE2B-A0CA-4750-A3E8-D2DA0A07AD76}" type="datetimeFigureOut">
              <a:rPr lang="en-US" smtClean="0"/>
              <a:t>2/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DE587A-3BE9-4BC5-97FE-96F359394D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F6F835-5DDC-4355-82BB-7B4ACFA4AA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35F9F9-7373-40DC-800D-DD74AD1248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78542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99DBFC-AC1A-436E-AA81-49743DF066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584159D-229A-4BED-9E6F-872E0AAF3F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5FC69F-C82C-4D97-B681-6A7143DAF5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ACE2B-A0CA-4750-A3E8-D2DA0A07AD76}" type="datetimeFigureOut">
              <a:rPr lang="en-US" smtClean="0"/>
              <a:t>2/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79E226-B3E0-46A8-86A9-CAD7F0B9BC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DDF234-55B4-444C-B14F-E13DC3B3ED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35F9F9-7373-40DC-800D-DD74AD1248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9613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E70C2A-801A-4F16-AC76-AB40C4633E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C43156D-6960-40FB-8CAB-3C6762B673C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033A69E-6256-4ED8-AB5C-32A4166DA36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610CAA6-F873-4CD8-A16A-A1E5E854FF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ACE2B-A0CA-4750-A3E8-D2DA0A07AD76}" type="datetimeFigureOut">
              <a:rPr lang="en-US" smtClean="0"/>
              <a:t>2/3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9A49CC7-D6FE-4FE4-9E50-596E6C4AF7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EC6109D-553F-4ABE-8135-309A315B62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35F9F9-7373-40DC-800D-DD74AD1248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06719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E14FDD-D8B5-4831-B461-8C8D907069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9002C7E-4437-4C69-9F29-008259D41B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30B94CC-CF46-4432-9468-27B997DDE41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DBB2DC5-D797-4D43-B0BE-2DCE52423F9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A617531-5A04-4052-B062-17AE3A6AB03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A9E0AA3-94EC-4DD1-A36B-DF6DA41AE2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ACE2B-A0CA-4750-A3E8-D2DA0A07AD76}" type="datetimeFigureOut">
              <a:rPr lang="en-US" smtClean="0"/>
              <a:t>2/3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768C4F8-896C-45C3-AC6C-104FAE0FA2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0E52072-D4D4-4223-A64A-B9222C4FAB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35F9F9-7373-40DC-800D-DD74AD1248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60463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E38658-9553-4D11-A48B-FC1C1300F7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7144F98-F77C-425B-86E8-49E6A408A6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ACE2B-A0CA-4750-A3E8-D2DA0A07AD76}" type="datetimeFigureOut">
              <a:rPr lang="en-US" smtClean="0"/>
              <a:t>2/3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92171D5-4298-4466-BD6B-72A264E794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7744774-EA4D-4DDE-B0FB-6D7CA495FE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35F9F9-7373-40DC-800D-DD74AD1248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11996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C5B41AC-EB67-476E-89F2-3BD594F7CB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ACE2B-A0CA-4750-A3E8-D2DA0A07AD76}" type="datetimeFigureOut">
              <a:rPr lang="en-US" smtClean="0"/>
              <a:t>2/3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EE15EBD-21B4-49E1-BA61-7756C5823B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EF9E3C7-3A96-47C7-B305-21AF3BEB47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35F9F9-7373-40DC-800D-DD74AD1248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38979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CB58D0-101F-4C63-94B8-E4316C1123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AA49E70-CBFC-4614-8D8B-7B31E4F27D0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6B0A84C-C920-4E7C-9ED6-03D8859CE2F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139D082-79B1-4116-B429-88B5E484E4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ACE2B-A0CA-4750-A3E8-D2DA0A07AD76}" type="datetimeFigureOut">
              <a:rPr lang="en-US" smtClean="0"/>
              <a:t>2/3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4FD38B9-CAAE-4EA5-BEC0-2D9B19597D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2FA1B7C-997E-4F2F-85FF-C21D6E9B78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35F9F9-7373-40DC-800D-DD74AD1248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12107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8D1DA9-3D27-4AB8-81F3-DF59F79ECA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5199175-1B81-4FF1-9642-95E3B18AE34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2127600-2477-44D6-A7E7-FE06C0E20CA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30813FE-72C4-4294-8510-CB9DEC5AC6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ACE2B-A0CA-4750-A3E8-D2DA0A07AD76}" type="datetimeFigureOut">
              <a:rPr lang="en-US" smtClean="0"/>
              <a:t>2/3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C496E85-FE77-4BCA-9737-F36E165041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1AF7811-F518-43F2-B7F5-573B92E2A0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35F9F9-7373-40DC-800D-DD74AD1248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28740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E73129C-B59C-4B46-A6ED-7C3DCC8321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B6EED6E-317E-4310-9D39-1A755E20DF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68A5EE-4152-4E84-8EB1-8E6FEE53847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4ACE2B-A0CA-4750-A3E8-D2DA0A07AD76}" type="datetimeFigureOut">
              <a:rPr lang="en-US" smtClean="0"/>
              <a:t>2/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FF1B0B-D942-4E3D-B9D7-CF00D0223D3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1D4B50-C6C3-447F-B6F0-681550DB6A9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35F9F9-7373-40DC-800D-DD74AD1248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14477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261DA521-9B82-47C1-AA17-C4E642444B0C}"/>
              </a:ext>
            </a:extLst>
          </p:cNvPr>
          <p:cNvSpPr/>
          <p:nvPr/>
        </p:nvSpPr>
        <p:spPr>
          <a:xfrm>
            <a:off x="180104" y="2396613"/>
            <a:ext cx="1596157" cy="141870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ersonal Determinants &amp; Change Objective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Knowledg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kill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elf-Efficacy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erceived Barriers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utcomes Expectations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64211532-FF01-44C3-A5FF-4A78645C8BF6}"/>
              </a:ext>
            </a:extLst>
          </p:cNvPr>
          <p:cNvSpPr/>
          <p:nvPr/>
        </p:nvSpPr>
        <p:spPr>
          <a:xfrm>
            <a:off x="2741471" y="205574"/>
            <a:ext cx="2538847" cy="219044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atient Performance Objective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dentify at-risk relative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dentify strategies for each relative based on age, closeness, and receptivity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repare a plan for contacting relative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ake initial contact with relatives to explain needs for LS testing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ffer relatives materials about LS associated cancer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ffer to connect relatives with provider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ffer ongoing support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C9F083B9-3FCB-4996-AE7A-DCE0B2D7C8F9}"/>
              </a:ext>
            </a:extLst>
          </p:cNvPr>
          <p:cNvSpPr/>
          <p:nvPr/>
        </p:nvSpPr>
        <p:spPr>
          <a:xfrm>
            <a:off x="5898579" y="632799"/>
            <a:ext cx="2225490" cy="130753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atient Behavioral Outcome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atients understand risks of LS and how to manage them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atients are prepared to contact relatives about LS risk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atients inform relatives about LS risk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3160ADF0-B111-4F8F-A060-2F3C804FD4E5}"/>
              </a:ext>
            </a:extLst>
          </p:cNvPr>
          <p:cNvSpPr/>
          <p:nvPr/>
        </p:nvSpPr>
        <p:spPr>
          <a:xfrm>
            <a:off x="8654963" y="2524074"/>
            <a:ext cx="1413826" cy="116378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ealth Outcome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mproved morbidity and mortality among patients’ relatives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A3BC80F5-311D-4BAA-8515-F29273D11556}"/>
              </a:ext>
            </a:extLst>
          </p:cNvPr>
          <p:cNvSpPr/>
          <p:nvPr/>
        </p:nvSpPr>
        <p:spPr>
          <a:xfrm>
            <a:off x="10390922" y="2530909"/>
            <a:ext cx="1413827" cy="116378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Quality of Lif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mproved QoL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mproved satisfaction with cascade screening process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19863E36-61A1-4882-803C-F3E2DEF8DAF5}"/>
              </a:ext>
            </a:extLst>
          </p:cNvPr>
          <p:cNvSpPr/>
          <p:nvPr/>
        </p:nvSpPr>
        <p:spPr>
          <a:xfrm>
            <a:off x="2741470" y="2745741"/>
            <a:ext cx="2538847" cy="969161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elative Performance Objective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ather information necessary to make an informed decision to receive genetic testing for L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eceive genetic testing for L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lan for the future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535E7299-18B9-4800-9310-1A24B75FF02B}"/>
              </a:ext>
            </a:extLst>
          </p:cNvPr>
          <p:cNvSpPr/>
          <p:nvPr/>
        </p:nvSpPr>
        <p:spPr>
          <a:xfrm>
            <a:off x="2741469" y="4401248"/>
            <a:ext cx="2538847" cy="124956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rovider Performance Objective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xplain why patients need to communicate risk information to relative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repare patients for communicating with relative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ollow up with patients on communication with relatives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B87258BA-347D-4E4B-8E88-05122BCA2D79}"/>
              </a:ext>
            </a:extLst>
          </p:cNvPr>
          <p:cNvSpPr/>
          <p:nvPr/>
        </p:nvSpPr>
        <p:spPr>
          <a:xfrm>
            <a:off x="5897941" y="2702902"/>
            <a:ext cx="2226128" cy="96916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elative Behavioral Outcome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elatives are informed about LS and LS testing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elatives receive testing for LS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95AAC233-737C-4014-9BC6-E46808B8B3D3}"/>
              </a:ext>
            </a:extLst>
          </p:cNvPr>
          <p:cNvSpPr/>
          <p:nvPr/>
        </p:nvSpPr>
        <p:spPr>
          <a:xfrm>
            <a:off x="5898579" y="4318057"/>
            <a:ext cx="2225490" cy="1415946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rovider Behavioral Outcome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roviders understand the importance of supporting cascade screening.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roviders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ommunicate with patients about the importance of cascade screening.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rovider support patients in using the workbook</a:t>
            </a:r>
          </a:p>
        </p:txBody>
      </p: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A3EE4327-3E78-452B-A5BA-A468112F0B5E}"/>
              </a:ext>
            </a:extLst>
          </p:cNvPr>
          <p:cNvCxnSpPr>
            <a:cxnSpLocks/>
            <a:stCxn id="6" idx="0"/>
          </p:cNvCxnSpPr>
          <p:nvPr/>
        </p:nvCxnSpPr>
        <p:spPr>
          <a:xfrm flipV="1">
            <a:off x="978183" y="1147047"/>
            <a:ext cx="1584908" cy="1249566"/>
          </a:xfrm>
          <a:prstGeom prst="straightConnector1">
            <a:avLst/>
          </a:prstGeom>
          <a:ln w="38100">
            <a:tailEnd type="triangle"/>
          </a:ln>
        </p:spPr>
        <p:style>
          <a:lnRef idx="3">
            <a:schemeClr val="accent4"/>
          </a:lnRef>
          <a:fillRef idx="0">
            <a:schemeClr val="accent4"/>
          </a:fillRef>
          <a:effectRef idx="2">
            <a:schemeClr val="accent4"/>
          </a:effectRef>
          <a:fontRef idx="minor">
            <a:schemeClr val="tx1"/>
          </a:fontRef>
        </p:style>
      </p:cxn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A6BAAD03-0062-46AC-ACD2-C637D8D9D886}"/>
              </a:ext>
            </a:extLst>
          </p:cNvPr>
          <p:cNvCxnSpPr>
            <a:cxnSpLocks/>
          </p:cNvCxnSpPr>
          <p:nvPr/>
        </p:nvCxnSpPr>
        <p:spPr>
          <a:xfrm>
            <a:off x="2123211" y="3261081"/>
            <a:ext cx="439880" cy="0"/>
          </a:xfrm>
          <a:prstGeom prst="straightConnector1">
            <a:avLst/>
          </a:prstGeom>
          <a:ln w="38100">
            <a:tailEnd type="triangle"/>
          </a:ln>
        </p:spPr>
        <p:style>
          <a:lnRef idx="3">
            <a:schemeClr val="accent4"/>
          </a:lnRef>
          <a:fillRef idx="0">
            <a:schemeClr val="accent4"/>
          </a:fillRef>
          <a:effectRef idx="2">
            <a:schemeClr val="accent4"/>
          </a:effectRef>
          <a:fontRef idx="minor">
            <a:schemeClr val="tx1"/>
          </a:fontRef>
        </p:style>
      </p:cxn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655AE75B-F23C-4DAF-86CC-DFF4A4A686E6}"/>
              </a:ext>
            </a:extLst>
          </p:cNvPr>
          <p:cNvCxnSpPr>
            <a:cxnSpLocks/>
          </p:cNvCxnSpPr>
          <p:nvPr/>
        </p:nvCxnSpPr>
        <p:spPr>
          <a:xfrm>
            <a:off x="1122211" y="3962177"/>
            <a:ext cx="1440880" cy="1249566"/>
          </a:xfrm>
          <a:prstGeom prst="straightConnector1">
            <a:avLst/>
          </a:prstGeom>
          <a:ln w="38100">
            <a:tailEnd type="triangle"/>
          </a:ln>
        </p:spPr>
        <p:style>
          <a:lnRef idx="3">
            <a:schemeClr val="accent4"/>
          </a:lnRef>
          <a:fillRef idx="0">
            <a:schemeClr val="accent4"/>
          </a:fillRef>
          <a:effectRef idx="2">
            <a:schemeClr val="accent4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8DE7C3B5-798B-45FA-BF83-1E9F15A6B008}"/>
              </a:ext>
            </a:extLst>
          </p:cNvPr>
          <p:cNvCxnSpPr>
            <a:cxnSpLocks/>
          </p:cNvCxnSpPr>
          <p:nvPr/>
        </p:nvCxnSpPr>
        <p:spPr>
          <a:xfrm>
            <a:off x="5458699" y="1301392"/>
            <a:ext cx="439880" cy="0"/>
          </a:xfrm>
          <a:prstGeom prst="straightConnector1">
            <a:avLst/>
          </a:prstGeom>
          <a:ln w="38100">
            <a:tailEnd type="triangle"/>
          </a:ln>
        </p:spPr>
        <p:style>
          <a:lnRef idx="3">
            <a:schemeClr val="accent4"/>
          </a:lnRef>
          <a:fillRef idx="0">
            <a:schemeClr val="accent4"/>
          </a:fillRef>
          <a:effectRef idx="2">
            <a:schemeClr val="accent4"/>
          </a:effectRef>
          <a:fontRef idx="minor">
            <a:schemeClr val="tx1"/>
          </a:fontRef>
        </p:style>
      </p:cxn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D2AA4CB5-2904-4813-9933-04E11E1F5794}"/>
              </a:ext>
            </a:extLst>
          </p:cNvPr>
          <p:cNvCxnSpPr>
            <a:cxnSpLocks/>
          </p:cNvCxnSpPr>
          <p:nvPr/>
        </p:nvCxnSpPr>
        <p:spPr>
          <a:xfrm>
            <a:off x="5458699" y="3230322"/>
            <a:ext cx="439880" cy="0"/>
          </a:xfrm>
          <a:prstGeom prst="straightConnector1">
            <a:avLst/>
          </a:prstGeom>
          <a:ln w="38100">
            <a:tailEnd type="triangle"/>
          </a:ln>
        </p:spPr>
        <p:style>
          <a:lnRef idx="3">
            <a:schemeClr val="accent4"/>
          </a:lnRef>
          <a:fillRef idx="0">
            <a:schemeClr val="accent4"/>
          </a:fillRef>
          <a:effectRef idx="2">
            <a:schemeClr val="accent4"/>
          </a:effectRef>
          <a:fontRef idx="minor">
            <a:schemeClr val="tx1"/>
          </a:fontRef>
        </p:style>
      </p:cxn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811192DD-7A99-4CDE-B236-FF15D56B73AC}"/>
              </a:ext>
            </a:extLst>
          </p:cNvPr>
          <p:cNvCxnSpPr>
            <a:cxnSpLocks/>
          </p:cNvCxnSpPr>
          <p:nvPr/>
        </p:nvCxnSpPr>
        <p:spPr>
          <a:xfrm>
            <a:off x="5458699" y="5117040"/>
            <a:ext cx="439880" cy="0"/>
          </a:xfrm>
          <a:prstGeom prst="straightConnector1">
            <a:avLst/>
          </a:prstGeom>
          <a:ln w="38100">
            <a:tailEnd type="triangle"/>
          </a:ln>
        </p:spPr>
        <p:style>
          <a:lnRef idx="3">
            <a:schemeClr val="accent4"/>
          </a:lnRef>
          <a:fillRef idx="0">
            <a:schemeClr val="accent4"/>
          </a:fillRef>
          <a:effectRef idx="2">
            <a:schemeClr val="accent4"/>
          </a:effectRef>
          <a:fontRef idx="minor">
            <a:schemeClr val="tx1"/>
          </a:fontRef>
        </p:style>
      </p:cxn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ACA39EAE-F610-435E-AA17-662DD52EB3D8}"/>
              </a:ext>
            </a:extLst>
          </p:cNvPr>
          <p:cNvCxnSpPr>
            <a:cxnSpLocks/>
          </p:cNvCxnSpPr>
          <p:nvPr/>
        </p:nvCxnSpPr>
        <p:spPr>
          <a:xfrm>
            <a:off x="8222339" y="3206578"/>
            <a:ext cx="263242" cy="0"/>
          </a:xfrm>
          <a:prstGeom prst="straightConnector1">
            <a:avLst/>
          </a:prstGeom>
          <a:ln w="38100">
            <a:tailEnd type="triangle"/>
          </a:ln>
        </p:spPr>
        <p:style>
          <a:lnRef idx="3">
            <a:schemeClr val="accent4"/>
          </a:lnRef>
          <a:fillRef idx="0">
            <a:schemeClr val="accent4"/>
          </a:fillRef>
          <a:effectRef idx="2">
            <a:schemeClr val="accent4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9535232E-4F21-4D3E-895B-D00FB0E844E8}"/>
              </a:ext>
            </a:extLst>
          </p:cNvPr>
          <p:cNvCxnSpPr>
            <a:cxnSpLocks/>
          </p:cNvCxnSpPr>
          <p:nvPr/>
        </p:nvCxnSpPr>
        <p:spPr>
          <a:xfrm>
            <a:off x="10127680" y="3187483"/>
            <a:ext cx="263242" cy="0"/>
          </a:xfrm>
          <a:prstGeom prst="straightConnector1">
            <a:avLst/>
          </a:prstGeom>
          <a:ln w="38100">
            <a:tailEnd type="triangle"/>
          </a:ln>
        </p:spPr>
        <p:style>
          <a:lnRef idx="3">
            <a:schemeClr val="accent4"/>
          </a:lnRef>
          <a:fillRef idx="0">
            <a:schemeClr val="accent4"/>
          </a:fillRef>
          <a:effectRef idx="2">
            <a:schemeClr val="accent4"/>
          </a:effectRef>
          <a:fontRef idx="minor">
            <a:schemeClr val="tx1"/>
          </a:fontRef>
        </p:style>
      </p:cxn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F43B86CB-80D7-4600-A832-495092BE4A9F}"/>
              </a:ext>
            </a:extLst>
          </p:cNvPr>
          <p:cNvCxnSpPr>
            <a:cxnSpLocks/>
          </p:cNvCxnSpPr>
          <p:nvPr/>
        </p:nvCxnSpPr>
        <p:spPr>
          <a:xfrm>
            <a:off x="8185634" y="1269371"/>
            <a:ext cx="1067729" cy="902103"/>
          </a:xfrm>
          <a:prstGeom prst="straightConnector1">
            <a:avLst/>
          </a:prstGeom>
          <a:ln w="38100">
            <a:tailEnd type="triangle"/>
          </a:ln>
        </p:spPr>
        <p:style>
          <a:lnRef idx="3">
            <a:schemeClr val="accent4"/>
          </a:lnRef>
          <a:fillRef idx="0">
            <a:schemeClr val="accent4"/>
          </a:fillRef>
          <a:effectRef idx="2">
            <a:schemeClr val="accent4"/>
          </a:effectRef>
          <a:fontRef idx="minor">
            <a:schemeClr val="tx1"/>
          </a:fontRef>
        </p:style>
      </p:cxn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0F591363-4CB7-4434-8E9C-2AB7BB5E02BD}"/>
              </a:ext>
            </a:extLst>
          </p:cNvPr>
          <p:cNvCxnSpPr>
            <a:cxnSpLocks/>
          </p:cNvCxnSpPr>
          <p:nvPr/>
        </p:nvCxnSpPr>
        <p:spPr>
          <a:xfrm flipV="1">
            <a:off x="8222339" y="3991099"/>
            <a:ext cx="1124631" cy="1220644"/>
          </a:xfrm>
          <a:prstGeom prst="straightConnector1">
            <a:avLst/>
          </a:prstGeom>
          <a:ln w="38100">
            <a:tailEnd type="triangle"/>
          </a:ln>
        </p:spPr>
        <p:style>
          <a:lnRef idx="3">
            <a:schemeClr val="accent4"/>
          </a:lnRef>
          <a:fillRef idx="0">
            <a:schemeClr val="accent4"/>
          </a:fillRef>
          <a:effectRef idx="2">
            <a:schemeClr val="accent4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970887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1B11E8E191C534092DD9CB1FEDDC7E1" ma:contentTypeVersion="14" ma:contentTypeDescription="Create a new document." ma:contentTypeScope="" ma:versionID="5233b0820f8dde3ec0cfc4dac510e7f8">
  <xsd:schema xmlns:xsd="http://www.w3.org/2001/XMLSchema" xmlns:xs="http://www.w3.org/2001/XMLSchema" xmlns:p="http://schemas.microsoft.com/office/2006/metadata/properties" xmlns:ns3="0860b4dc-46b6-4edc-abce-44931b8d717c" xmlns:ns4="a90d648d-4026-4489-a39d-980676c113d4" targetNamespace="http://schemas.microsoft.com/office/2006/metadata/properties" ma:root="true" ma:fieldsID="5a3cf67dca02a37305fc76eb6a597da2" ns3:_="" ns4:_="">
    <xsd:import namespace="0860b4dc-46b6-4edc-abce-44931b8d717c"/>
    <xsd:import namespace="a90d648d-4026-4489-a39d-980676c113d4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3:MediaLengthInSeconds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Location" minOccurs="0"/>
                <xsd:element ref="ns3:MediaServiceOCR" minOccurs="0"/>
                <xsd:element ref="ns4:SharedWithUsers" minOccurs="0"/>
                <xsd:element ref="ns4:SharedWithDetails" minOccurs="0"/>
                <xsd:element ref="ns4:SharingHintHash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860b4dc-46b6-4edc-abce-44931b8d717c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3" nillable="true" ma:displayName="Length (seconds)" ma:internalName="MediaLengthInSeconds" ma:readOnly="true">
      <xsd:simpleType>
        <xsd:restriction base="dms:Unknown"/>
      </xsd:simpleType>
    </xsd:element>
    <xsd:element name="MediaServiceAutoTags" ma:index="14" nillable="true" ma:displayName="Tags" ma:internalName="MediaServiceAutoTags" ma:readOnly="true">
      <xsd:simpleType>
        <xsd:restriction base="dms:Text"/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Location" ma:index="17" nillable="true" ma:displayName="Location" ma:internalName="MediaServiceLocation" ma:readOnly="true">
      <xsd:simpleType>
        <xsd:restriction base="dms:Text"/>
      </xsd:simpleType>
    </xsd:element>
    <xsd:element name="MediaServiceOCR" ma:index="18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90d648d-4026-4489-a39d-980676c113d4" elementFormDefault="qualified">
    <xsd:import namespace="http://schemas.microsoft.com/office/2006/documentManagement/types"/>
    <xsd:import namespace="http://schemas.microsoft.com/office/infopath/2007/PartnerControls"/>
    <xsd:element name="SharedWithUsers" ma:index="19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0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1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84739631-A661-46B1-BA99-075B673127A8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860b4dc-46b6-4edc-abce-44931b8d717c"/>
    <ds:schemaRef ds:uri="a90d648d-4026-4489-a39d-980676c113d4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2864F502-9EEA-473C-96D4-9DC5F0424DD6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6A6A5850-20C4-45A1-B773-6D97DD188B57}">
  <ds:schemaRefs>
    <ds:schemaRef ds:uri="http://schemas.openxmlformats.org/package/2006/metadata/core-properties"/>
    <ds:schemaRef ds:uri="0860b4dc-46b6-4edc-abce-44931b8d717c"/>
    <ds:schemaRef ds:uri="a90d648d-4026-4489-a39d-980676c113d4"/>
    <ds:schemaRef ds:uri="http://schemas.microsoft.com/office/infopath/2007/PartnerControls"/>
    <ds:schemaRef ds:uri="http://purl.org/dc/terms/"/>
    <ds:schemaRef ds:uri="http://schemas.microsoft.com/office/2006/documentManagement/types"/>
    <ds:schemaRef ds:uri="http://purl.org/dc/elements/1.1/"/>
    <ds:schemaRef ds:uri="http://schemas.microsoft.com/office/2006/metadata/properties"/>
    <ds:schemaRef ds:uri="http://www.w3.org/XML/1998/namespace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475</TotalTime>
  <Words>212</Words>
  <Application>Microsoft Office PowerPoint</Application>
  <PresentationFormat>Widescreen</PresentationFormat>
  <Paragraphs>3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ssero, Lauren Elizabeth</dc:creator>
  <cp:lastModifiedBy>Roberts, Megan Clarke</cp:lastModifiedBy>
  <cp:revision>2</cp:revision>
  <dcterms:created xsi:type="dcterms:W3CDTF">2022-01-25T14:44:20Z</dcterms:created>
  <dcterms:modified xsi:type="dcterms:W3CDTF">2022-02-04T01:57:4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1B11E8E191C534092DD9CB1FEDDC7E1</vt:lpwstr>
  </property>
</Properties>
</file>